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746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E:\Copy%20of%20MTT%20Analysis%20%20(Nil)%20pre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MTT%20Analysis%20(diffNil)%20final%20%20(1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Cycle1!$B$79</c:f>
              <c:strCache>
                <c:ptCount val="1"/>
                <c:pt idx="0">
                  <c:v>NILO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ycle1!$D$66:$M$66</c:f>
                <c:numCache>
                  <c:formatCode>General</c:formatCode>
                  <c:ptCount val="10"/>
                  <c:pt idx="0">
                    <c:v>3.1173204923802862</c:v>
                  </c:pt>
                  <c:pt idx="1">
                    <c:v>2.9440400609062483</c:v>
                  </c:pt>
                  <c:pt idx="2">
                    <c:v>8.3978380538896324</c:v>
                  </c:pt>
                  <c:pt idx="3">
                    <c:v>10.746866824100216</c:v>
                  </c:pt>
                  <c:pt idx="4">
                    <c:v>9.6345908309766823</c:v>
                  </c:pt>
                  <c:pt idx="5">
                    <c:v>5.9483576333202492</c:v>
                  </c:pt>
                  <c:pt idx="6">
                    <c:v>7.0926579101099092</c:v>
                  </c:pt>
                  <c:pt idx="7">
                    <c:v>7.7656092729117283</c:v>
                  </c:pt>
                  <c:pt idx="8">
                    <c:v>8.5573866997220946</c:v>
                  </c:pt>
                  <c:pt idx="9">
                    <c:v>3.4437633412511</c:v>
                  </c:pt>
                </c:numCache>
              </c:numRef>
            </c:plus>
            <c:minus>
              <c:numRef>
                <c:f>Cycle1!$D$66:$M$66</c:f>
                <c:numCache>
                  <c:formatCode>General</c:formatCode>
                  <c:ptCount val="10"/>
                  <c:pt idx="0">
                    <c:v>3.1173204923802862</c:v>
                  </c:pt>
                  <c:pt idx="1">
                    <c:v>2.9440400609062483</c:v>
                  </c:pt>
                  <c:pt idx="2">
                    <c:v>8.3978380538896324</c:v>
                  </c:pt>
                  <c:pt idx="3">
                    <c:v>10.746866824100216</c:v>
                  </c:pt>
                  <c:pt idx="4">
                    <c:v>9.6345908309766823</c:v>
                  </c:pt>
                  <c:pt idx="5">
                    <c:v>5.9483576333202492</c:v>
                  </c:pt>
                  <c:pt idx="6">
                    <c:v>7.0926579101099092</c:v>
                  </c:pt>
                  <c:pt idx="7">
                    <c:v>7.7656092729117283</c:v>
                  </c:pt>
                  <c:pt idx="8">
                    <c:v>8.5573866997220946</c:v>
                  </c:pt>
                  <c:pt idx="9">
                    <c:v>3.4437633412511</c:v>
                  </c:pt>
                </c:numCache>
              </c:numRef>
            </c:minus>
          </c:errBars>
          <c:cat>
            <c:strRef>
              <c:f>Cycle1!$C$78:$L$78</c:f>
              <c:strCache>
                <c:ptCount val="10"/>
                <c:pt idx="0">
                  <c:v>Veh</c:v>
                </c:pt>
                <c:pt idx="1">
                  <c:v>0.01</c:v>
                </c:pt>
                <c:pt idx="2">
                  <c:v>0.1</c:v>
                </c:pt>
                <c:pt idx="3">
                  <c:v>1</c:v>
                </c:pt>
                <c:pt idx="4">
                  <c:v>10</c:v>
                </c:pt>
                <c:pt idx="5">
                  <c:v>20</c:v>
                </c:pt>
                <c:pt idx="6">
                  <c:v>40</c:v>
                </c:pt>
                <c:pt idx="7">
                  <c:v>60</c:v>
                </c:pt>
                <c:pt idx="8">
                  <c:v>80</c:v>
                </c:pt>
                <c:pt idx="9">
                  <c:v>100</c:v>
                </c:pt>
              </c:strCache>
            </c:strRef>
          </c:cat>
          <c:val>
            <c:numRef>
              <c:f>Cycle1!$C$79:$L$79</c:f>
              <c:numCache>
                <c:formatCode>General</c:formatCode>
                <c:ptCount val="10"/>
                <c:pt idx="0">
                  <c:v>134.91634839119254</c:v>
                </c:pt>
                <c:pt idx="1">
                  <c:v>112.5224900912433</c:v>
                </c:pt>
                <c:pt idx="2">
                  <c:v>104.41768685244001</c:v>
                </c:pt>
                <c:pt idx="3">
                  <c:v>101.72324905842454</c:v>
                </c:pt>
                <c:pt idx="4">
                  <c:v>105.55971530939883</c:v>
                </c:pt>
                <c:pt idx="5">
                  <c:v>89.511412848396958</c:v>
                </c:pt>
                <c:pt idx="6">
                  <c:v>85.972250939275341</c:v>
                </c:pt>
                <c:pt idx="7">
                  <c:v>88.621023457695614</c:v>
                </c:pt>
                <c:pt idx="8">
                  <c:v>83.892552473451772</c:v>
                </c:pt>
                <c:pt idx="9">
                  <c:v>95.91165330980733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EE3B-4B89-AFFD-2E15F5064B92}"/>
            </c:ext>
          </c:extLst>
        </c:ser>
        <c:ser>
          <c:idx val="1"/>
          <c:order val="1"/>
          <c:tx>
            <c:strRef>
              <c:f>Cycle1!$B$80</c:f>
              <c:strCache>
                <c:ptCount val="1"/>
                <c:pt idx="0">
                  <c:v>IMA</c:v>
                </c:pt>
              </c:strCache>
            </c:strRef>
          </c:tx>
          <c:spPr>
            <a:ln>
              <a:solidFill>
                <a:srgbClr val="00B050"/>
              </a:solidFill>
            </a:ln>
          </c:spPr>
          <c:marker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ycle1!$D$72:$M$72</c:f>
                <c:numCache>
                  <c:formatCode>General</c:formatCode>
                  <c:ptCount val="10"/>
                  <c:pt idx="0">
                    <c:v>5.8508551633455239</c:v>
                  </c:pt>
                  <c:pt idx="1">
                    <c:v>0.80918626806227778</c:v>
                  </c:pt>
                  <c:pt idx="2">
                    <c:v>2.3500761329642077</c:v>
                  </c:pt>
                  <c:pt idx="3">
                    <c:v>2.8827988813361816</c:v>
                  </c:pt>
                  <c:pt idx="4">
                    <c:v>0.82690677296439452</c:v>
                  </c:pt>
                  <c:pt idx="5">
                    <c:v>3.0005501709381162</c:v>
                  </c:pt>
                  <c:pt idx="6">
                    <c:v>17.433979562659932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</c:numCache>
              </c:numRef>
            </c:plus>
            <c:minus>
              <c:numRef>
                <c:f>Cycle1!$D$72:$M$72</c:f>
                <c:numCache>
                  <c:formatCode>General</c:formatCode>
                  <c:ptCount val="10"/>
                  <c:pt idx="0">
                    <c:v>5.8508551633455239</c:v>
                  </c:pt>
                  <c:pt idx="1">
                    <c:v>0.80918626806227778</c:v>
                  </c:pt>
                  <c:pt idx="2">
                    <c:v>2.3500761329642077</c:v>
                  </c:pt>
                  <c:pt idx="3">
                    <c:v>2.8827988813361816</c:v>
                  </c:pt>
                  <c:pt idx="4">
                    <c:v>0.82690677296439452</c:v>
                  </c:pt>
                  <c:pt idx="5">
                    <c:v>3.0005501709381162</c:v>
                  </c:pt>
                  <c:pt idx="6">
                    <c:v>17.433979562659932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</c:numCache>
              </c:numRef>
            </c:minus>
          </c:errBars>
          <c:cat>
            <c:strRef>
              <c:f>Cycle1!$C$78:$L$78</c:f>
              <c:strCache>
                <c:ptCount val="10"/>
                <c:pt idx="0">
                  <c:v>Veh</c:v>
                </c:pt>
                <c:pt idx="1">
                  <c:v>0.01</c:v>
                </c:pt>
                <c:pt idx="2">
                  <c:v>0.1</c:v>
                </c:pt>
                <c:pt idx="3">
                  <c:v>1</c:v>
                </c:pt>
                <c:pt idx="4">
                  <c:v>10</c:v>
                </c:pt>
                <c:pt idx="5">
                  <c:v>20</c:v>
                </c:pt>
                <c:pt idx="6">
                  <c:v>40</c:v>
                </c:pt>
                <c:pt idx="7">
                  <c:v>60</c:v>
                </c:pt>
                <c:pt idx="8">
                  <c:v>80</c:v>
                </c:pt>
                <c:pt idx="9">
                  <c:v>100</c:v>
                </c:pt>
              </c:strCache>
            </c:strRef>
          </c:cat>
          <c:val>
            <c:numRef>
              <c:f>Cycle1!$C$80:$L$80</c:f>
              <c:numCache>
                <c:formatCode>General</c:formatCode>
                <c:ptCount val="10"/>
                <c:pt idx="0">
                  <c:v>122.70489745298418</c:v>
                </c:pt>
                <c:pt idx="1">
                  <c:v>104.49653006924162</c:v>
                </c:pt>
                <c:pt idx="2">
                  <c:v>94.910118735647089</c:v>
                </c:pt>
                <c:pt idx="3">
                  <c:v>95.019851413752747</c:v>
                </c:pt>
                <c:pt idx="4">
                  <c:v>99.714367086426364</c:v>
                </c:pt>
                <c:pt idx="5">
                  <c:v>97.972723864522052</c:v>
                </c:pt>
                <c:pt idx="6">
                  <c:v>72.764339291033536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EE3B-4B89-AFFD-2E15F5064B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1678208"/>
        <c:axId val="91586560"/>
      </c:lineChart>
      <c:catAx>
        <c:axId val="9167820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GB" sz="1100">
                    <a:latin typeface="+mn-lt"/>
                  </a:rPr>
                  <a:t>Drug</a:t>
                </a:r>
                <a:r>
                  <a:rPr lang="en-GB" sz="1100" baseline="0">
                    <a:latin typeface="+mn-lt"/>
                  </a:rPr>
                  <a:t> Concentrations (</a:t>
                </a:r>
                <a:r>
                  <a:rPr lang="en-GB" sz="1100" baseline="0">
                    <a:latin typeface="+mn-lt"/>
                    <a:cs typeface="Times New Roman" panose="02020603050405020304" pitchFamily="18" charset="0"/>
                  </a:rPr>
                  <a:t>µM</a:t>
                </a:r>
                <a:r>
                  <a:rPr lang="en-GB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en-GB"/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crossAx val="91586560"/>
        <c:crosses val="autoZero"/>
        <c:auto val="1"/>
        <c:lblAlgn val="ctr"/>
        <c:lblOffset val="100"/>
        <c:noMultiLvlLbl val="0"/>
      </c:catAx>
      <c:valAx>
        <c:axId val="9158656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GB" sz="1100"/>
                  <a:t>Percentage</a:t>
                </a:r>
                <a:r>
                  <a:rPr lang="en-GB" sz="1100" baseline="0"/>
                  <a:t> Viability</a:t>
                </a:r>
                <a:endParaRPr lang="en-GB" sz="11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167820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spPr>
    <a:ln>
      <a:solidFill>
        <a:sysClr val="windowText" lastClr="000000"/>
      </a:solidFill>
    </a:ln>
  </c:sp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Cycle1!$B$79</c:f>
              <c:strCache>
                <c:ptCount val="1"/>
                <c:pt idx="0">
                  <c:v>NILO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ycle1!$D$65:$M$65</c:f>
                <c:numCache>
                  <c:formatCode>General</c:formatCode>
                  <c:ptCount val="10"/>
                  <c:pt idx="0">
                    <c:v>7.4121200971973034</c:v>
                  </c:pt>
                  <c:pt idx="1">
                    <c:v>10.243515186926555</c:v>
                  </c:pt>
                  <c:pt idx="2">
                    <c:v>10.811273619842988</c:v>
                  </c:pt>
                  <c:pt idx="3">
                    <c:v>4.8951418795749291</c:v>
                  </c:pt>
                  <c:pt idx="4">
                    <c:v>11.486949598335709</c:v>
                  </c:pt>
                  <c:pt idx="5">
                    <c:v>13.354756241237967</c:v>
                  </c:pt>
                  <c:pt idx="6">
                    <c:v>13.07674326146684</c:v>
                  </c:pt>
                  <c:pt idx="7">
                    <c:v>10.993316000478853</c:v>
                  </c:pt>
                  <c:pt idx="8">
                    <c:v>14.104072291790404</c:v>
                  </c:pt>
                  <c:pt idx="9">
                    <c:v>6.4498464931615667</c:v>
                  </c:pt>
                </c:numCache>
              </c:numRef>
            </c:plus>
            <c:minus>
              <c:numRef>
                <c:f>Cycle1!$D$65:$M$65</c:f>
                <c:numCache>
                  <c:formatCode>General</c:formatCode>
                  <c:ptCount val="10"/>
                  <c:pt idx="0">
                    <c:v>7.4121200971973034</c:v>
                  </c:pt>
                  <c:pt idx="1">
                    <c:v>10.243515186926555</c:v>
                  </c:pt>
                  <c:pt idx="2">
                    <c:v>10.811273619842988</c:v>
                  </c:pt>
                  <c:pt idx="3">
                    <c:v>4.8951418795749291</c:v>
                  </c:pt>
                  <c:pt idx="4">
                    <c:v>11.486949598335709</c:v>
                  </c:pt>
                  <c:pt idx="5">
                    <c:v>13.354756241237967</c:v>
                  </c:pt>
                  <c:pt idx="6">
                    <c:v>13.07674326146684</c:v>
                  </c:pt>
                  <c:pt idx="7">
                    <c:v>10.993316000478853</c:v>
                  </c:pt>
                  <c:pt idx="8">
                    <c:v>14.104072291790404</c:v>
                  </c:pt>
                  <c:pt idx="9">
                    <c:v>6.4498464931615667</c:v>
                  </c:pt>
                </c:numCache>
              </c:numRef>
            </c:minus>
          </c:errBars>
          <c:cat>
            <c:strRef>
              <c:f>Cycle1!$C$78:$L$78</c:f>
              <c:strCache>
                <c:ptCount val="10"/>
                <c:pt idx="0">
                  <c:v>Veh</c:v>
                </c:pt>
                <c:pt idx="1">
                  <c:v>0.01</c:v>
                </c:pt>
                <c:pt idx="2">
                  <c:v>0.1</c:v>
                </c:pt>
                <c:pt idx="3">
                  <c:v>1</c:v>
                </c:pt>
                <c:pt idx="4">
                  <c:v>10</c:v>
                </c:pt>
                <c:pt idx="5">
                  <c:v>20</c:v>
                </c:pt>
                <c:pt idx="6">
                  <c:v>40</c:v>
                </c:pt>
                <c:pt idx="7">
                  <c:v>60</c:v>
                </c:pt>
                <c:pt idx="8">
                  <c:v>80</c:v>
                </c:pt>
                <c:pt idx="9">
                  <c:v>100</c:v>
                </c:pt>
              </c:strCache>
            </c:strRef>
          </c:cat>
          <c:val>
            <c:numRef>
              <c:f>Cycle1!$C$79:$L$79</c:f>
              <c:numCache>
                <c:formatCode>General</c:formatCode>
                <c:ptCount val="10"/>
                <c:pt idx="0">
                  <c:v>101.86596128025883</c:v>
                </c:pt>
                <c:pt idx="1">
                  <c:v>74.239612502681609</c:v>
                </c:pt>
                <c:pt idx="2">
                  <c:v>66.141010316680038</c:v>
                </c:pt>
                <c:pt idx="3">
                  <c:v>69.363307819245904</c:v>
                </c:pt>
                <c:pt idx="4">
                  <c:v>71.467993843161153</c:v>
                </c:pt>
                <c:pt idx="5">
                  <c:v>67.484990090380691</c:v>
                </c:pt>
                <c:pt idx="6">
                  <c:v>59.269386118197041</c:v>
                </c:pt>
                <c:pt idx="7">
                  <c:v>54.524440717753549</c:v>
                </c:pt>
                <c:pt idx="8">
                  <c:v>68.365358397282776</c:v>
                </c:pt>
                <c:pt idx="9">
                  <c:v>-0.6759464663442473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B716-4730-BCEC-E3935D70A03C}"/>
            </c:ext>
          </c:extLst>
        </c:ser>
        <c:ser>
          <c:idx val="1"/>
          <c:order val="1"/>
          <c:tx>
            <c:strRef>
              <c:f>Cycle1!$B$80</c:f>
              <c:strCache>
                <c:ptCount val="1"/>
                <c:pt idx="0">
                  <c:v>IMA</c:v>
                </c:pt>
              </c:strCache>
            </c:strRef>
          </c:tx>
          <c:spPr>
            <a:ln>
              <a:solidFill>
                <a:srgbClr val="00B050"/>
              </a:solidFill>
            </a:ln>
          </c:spPr>
          <c:marker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ycle1!$D$71:$M$71</c:f>
                <c:numCache>
                  <c:formatCode>General</c:formatCode>
                  <c:ptCount val="10"/>
                  <c:pt idx="0">
                    <c:v>2.4800529254675938</c:v>
                  </c:pt>
                  <c:pt idx="1">
                    <c:v>1.7743368148262391</c:v>
                  </c:pt>
                  <c:pt idx="2">
                    <c:v>10.610829546070196</c:v>
                  </c:pt>
                  <c:pt idx="3">
                    <c:v>9.247678122389777</c:v>
                  </c:pt>
                  <c:pt idx="4">
                    <c:v>10.991198472499478</c:v>
                  </c:pt>
                  <c:pt idx="5">
                    <c:v>15.220706023771234</c:v>
                  </c:pt>
                  <c:pt idx="6">
                    <c:v>12.145676959643581</c:v>
                  </c:pt>
                  <c:pt idx="7">
                    <c:v>5.250889283948978</c:v>
                  </c:pt>
                  <c:pt idx="8">
                    <c:v>11.410496283181155</c:v>
                  </c:pt>
                  <c:pt idx="9">
                    <c:v>7.8177505477515563</c:v>
                  </c:pt>
                </c:numCache>
              </c:numRef>
            </c:plus>
            <c:minus>
              <c:numRef>
                <c:f>Cycle1!$D$71:$M$71</c:f>
                <c:numCache>
                  <c:formatCode>General</c:formatCode>
                  <c:ptCount val="10"/>
                  <c:pt idx="0">
                    <c:v>2.4800529254675938</c:v>
                  </c:pt>
                  <c:pt idx="1">
                    <c:v>1.7743368148262391</c:v>
                  </c:pt>
                  <c:pt idx="2">
                    <c:v>10.610829546070196</c:v>
                  </c:pt>
                  <c:pt idx="3">
                    <c:v>9.247678122389777</c:v>
                  </c:pt>
                  <c:pt idx="4">
                    <c:v>10.991198472499478</c:v>
                  </c:pt>
                  <c:pt idx="5">
                    <c:v>15.220706023771234</c:v>
                  </c:pt>
                  <c:pt idx="6">
                    <c:v>12.145676959643581</c:v>
                  </c:pt>
                  <c:pt idx="7">
                    <c:v>5.250889283948978</c:v>
                  </c:pt>
                  <c:pt idx="8">
                    <c:v>11.410496283181155</c:v>
                  </c:pt>
                  <c:pt idx="9">
                    <c:v>7.8177505477515563</c:v>
                  </c:pt>
                </c:numCache>
              </c:numRef>
            </c:minus>
          </c:errBars>
          <c:cat>
            <c:strRef>
              <c:f>Cycle1!$C$78:$L$78</c:f>
              <c:strCache>
                <c:ptCount val="10"/>
                <c:pt idx="0">
                  <c:v>Veh</c:v>
                </c:pt>
                <c:pt idx="1">
                  <c:v>0.01</c:v>
                </c:pt>
                <c:pt idx="2">
                  <c:v>0.1</c:v>
                </c:pt>
                <c:pt idx="3">
                  <c:v>1</c:v>
                </c:pt>
                <c:pt idx="4">
                  <c:v>10</c:v>
                </c:pt>
                <c:pt idx="5">
                  <c:v>20</c:v>
                </c:pt>
                <c:pt idx="6">
                  <c:v>40</c:v>
                </c:pt>
                <c:pt idx="7">
                  <c:v>60</c:v>
                </c:pt>
                <c:pt idx="8">
                  <c:v>80</c:v>
                </c:pt>
                <c:pt idx="9">
                  <c:v>100</c:v>
                </c:pt>
              </c:strCache>
            </c:strRef>
          </c:cat>
          <c:val>
            <c:numRef>
              <c:f>Cycle1!$C$80:$L$80</c:f>
              <c:numCache>
                <c:formatCode>General</c:formatCode>
                <c:ptCount val="10"/>
                <c:pt idx="0">
                  <c:v>96.886520405144324</c:v>
                </c:pt>
                <c:pt idx="1">
                  <c:v>81.09828477497409</c:v>
                </c:pt>
                <c:pt idx="2">
                  <c:v>82.853315590508217</c:v>
                </c:pt>
                <c:pt idx="3">
                  <c:v>77.941714966551913</c:v>
                </c:pt>
                <c:pt idx="4">
                  <c:v>78.282556057365497</c:v>
                </c:pt>
                <c:pt idx="5">
                  <c:v>83.10991179492602</c:v>
                </c:pt>
                <c:pt idx="6">
                  <c:v>83.964196443536764</c:v>
                </c:pt>
                <c:pt idx="7">
                  <c:v>69.894161854174754</c:v>
                </c:pt>
                <c:pt idx="8">
                  <c:v>51.991333176180859</c:v>
                </c:pt>
                <c:pt idx="9">
                  <c:v>8.350879483198353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B716-4730-BCEC-E3935D70A0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1465728"/>
        <c:axId val="91587136"/>
      </c:lineChart>
      <c:catAx>
        <c:axId val="914657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GB" sz="1100"/>
                  <a:t>Drug</a:t>
                </a:r>
                <a:r>
                  <a:rPr lang="en-GB" sz="1100" baseline="0"/>
                  <a:t> Concentrations (µM</a:t>
                </a:r>
                <a:r>
                  <a:rPr lang="en-GB" baseline="0"/>
                  <a:t>)  </a:t>
                </a:r>
                <a:endParaRPr lang="en-GB"/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crossAx val="91587136"/>
        <c:crosses val="autoZero"/>
        <c:auto val="1"/>
        <c:lblAlgn val="ctr"/>
        <c:lblOffset val="100"/>
        <c:noMultiLvlLbl val="0"/>
      </c:catAx>
      <c:valAx>
        <c:axId val="9158713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GB" sz="1100"/>
                  <a:t>Percentage</a:t>
                </a:r>
                <a:r>
                  <a:rPr lang="en-GB" sz="1100" baseline="0"/>
                  <a:t> Viability</a:t>
                </a:r>
                <a:endParaRPr lang="en-GB" sz="11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146572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spPr>
    <a:ln>
      <a:solidFill>
        <a:sysClr val="windowText" lastClr="000000"/>
      </a:solidFill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7E43B-BF6B-4B73-8D0C-4979D601C1CD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3BCA0-530C-4325-947D-6A32F00495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2195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7E43B-BF6B-4B73-8D0C-4979D601C1CD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3BCA0-530C-4325-947D-6A32F00495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9632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7E43B-BF6B-4B73-8D0C-4979D601C1CD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3BCA0-530C-4325-947D-6A32F00495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60975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7E43B-BF6B-4B73-8D0C-4979D601C1CD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3BCA0-530C-4325-947D-6A32F00495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23982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7E43B-BF6B-4B73-8D0C-4979D601C1CD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3BCA0-530C-4325-947D-6A32F00495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6695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7E43B-BF6B-4B73-8D0C-4979D601C1CD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3BCA0-530C-4325-947D-6A32F00495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75507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7E43B-BF6B-4B73-8D0C-4979D601C1CD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3BCA0-530C-4325-947D-6A32F00495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95545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7E43B-BF6B-4B73-8D0C-4979D601C1CD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3BCA0-530C-4325-947D-6A32F00495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8157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7E43B-BF6B-4B73-8D0C-4979D601C1CD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3BCA0-530C-4325-947D-6A32F00495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79093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7E43B-BF6B-4B73-8D0C-4979D601C1CD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3BCA0-530C-4325-947D-6A32F00495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5147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7E43B-BF6B-4B73-8D0C-4979D601C1CD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3BCA0-530C-4325-947D-6A32F00495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88009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97E43B-BF6B-4B73-8D0C-4979D601C1CD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03BCA0-530C-4325-947D-6A32F00495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79898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5211602"/>
              </p:ext>
            </p:extLst>
          </p:nvPr>
        </p:nvGraphicFramePr>
        <p:xfrm>
          <a:off x="2771800" y="379674"/>
          <a:ext cx="457136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920" y="1222"/>
            <a:ext cx="25508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upplementary Figure 1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043608" y="961970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 smtClean="0"/>
              <a:t>Suppl</a:t>
            </a:r>
            <a:r>
              <a:rPr lang="en-GB" dirty="0" smtClean="0"/>
              <a:t> Fig 1A</a:t>
            </a:r>
            <a:endParaRPr lang="en-GB" dirty="0"/>
          </a:p>
        </p:txBody>
      </p:sp>
      <p:graphicFrame>
        <p:nvGraphicFramePr>
          <p:cNvPr id="7" name="Chart 6"/>
          <p:cNvGraphicFramePr/>
          <p:nvPr>
            <p:extLst>
              <p:ext uri="{D42A27DB-BD31-4B8C-83A1-F6EECF244321}">
                <p14:modId xmlns:p14="http://schemas.microsoft.com/office/powerpoint/2010/main" val="656476222"/>
              </p:ext>
            </p:extLst>
          </p:nvPr>
        </p:nvGraphicFramePr>
        <p:xfrm>
          <a:off x="2771800" y="371703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1043608" y="3851756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 smtClean="0"/>
              <a:t>Suppl</a:t>
            </a:r>
            <a:r>
              <a:rPr lang="en-GB" smtClean="0"/>
              <a:t> Fig 1B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215872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23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University of Liverpoo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ushpakom, Sudeep</dc:creator>
  <cp:lastModifiedBy>Pushpakom, Sudeep</cp:lastModifiedBy>
  <cp:revision>4</cp:revision>
  <dcterms:created xsi:type="dcterms:W3CDTF">2018-07-05T11:22:12Z</dcterms:created>
  <dcterms:modified xsi:type="dcterms:W3CDTF">2018-11-02T18:23:27Z</dcterms:modified>
</cp:coreProperties>
</file>